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96E0769-A816-462D-B5AF-826891F88324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65310BF-099A-4197-A7F0-0AAB524E3D57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47CF01D-2443-4E31-BCB6-9BD70F582565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AE5D362-347D-4736-B225-466AD328506C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583A5BE-C53A-4500-8617-5FD62750714F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DA24597-2A3E-4588-A767-5EEB0B622161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BC1F7F3-FB18-413A-A9FA-09A343B40897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A9CA6B8-AD7C-464C-9819-78A67D3B45CE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364598C-A279-4C17-9C3F-35DCBEDFA718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EF3752C-276B-48AB-BF2A-49BD6DCAD057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4F2F5D9-FB73-48C9-8C85-C34B78D5B063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9BE5327-2E83-4E3E-9FA1-F677E5FDAF4C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C7FDC5-967E-498E-9F56-0584B3286CF8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4" descr=""/>
          <p:cNvPicPr/>
          <p:nvPr/>
        </p:nvPicPr>
        <p:blipFill>
          <a:blip r:embed="rId1"/>
          <a:stretch/>
        </p:blipFill>
        <p:spPr>
          <a:xfrm>
            <a:off x="1295280" y="1523880"/>
            <a:ext cx="6172200" cy="4048200"/>
          </a:xfrm>
          <a:prstGeom prst="rect">
            <a:avLst/>
          </a:prstGeom>
          <a:ln w="0">
            <a:noFill/>
          </a:ln>
        </p:spPr>
      </p:pic>
      <p:sp>
        <p:nvSpPr>
          <p:cNvPr id="40" name="Rectangle 2"/>
          <p:cNvSpPr/>
          <p:nvPr/>
        </p:nvSpPr>
        <p:spPr>
          <a:xfrm>
            <a:off x="1419120" y="730080"/>
            <a:ext cx="64360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7. MeDIP/NimbleGen Promoter + CpGi Arr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Tiling region): Methylation analysis of Igf2r imprint control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Rectangle 13"/>
          <p:cNvSpPr/>
          <p:nvPr/>
        </p:nvSpPr>
        <p:spPr>
          <a:xfrm rot="16200000">
            <a:off x="239040" y="3907080"/>
            <a:ext cx="1411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caled log2 rati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6688080" y="2209680"/>
            <a:ext cx="550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no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gf2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4"/>
          <p:cNvSpPr/>
          <p:nvPr/>
        </p:nvSpPr>
        <p:spPr>
          <a:xfrm>
            <a:off x="3508200" y="1905120"/>
            <a:ext cx="457200" cy="380988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5"/>
          <p:cNvSpPr/>
          <p:nvPr/>
        </p:nvSpPr>
        <p:spPr>
          <a:xfrm>
            <a:off x="3660840" y="2438280"/>
            <a:ext cx="838080" cy="1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6"/>
          <p:cNvSpPr/>
          <p:nvPr/>
        </p:nvSpPr>
        <p:spPr>
          <a:xfrm flipH="1">
            <a:off x="6692760" y="2438280"/>
            <a:ext cx="457200" cy="1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7"/>
          <p:cNvSpPr/>
          <p:nvPr/>
        </p:nvSpPr>
        <p:spPr>
          <a:xfrm>
            <a:off x="3580560" y="2286000"/>
            <a:ext cx="804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C0091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4"/>
          <p:cNvSpPr/>
          <p:nvPr/>
        </p:nvSpPr>
        <p:spPr>
          <a:xfrm>
            <a:off x="3660840" y="2438280"/>
            <a:ext cx="144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4"/>
          <p:cNvSpPr/>
          <p:nvPr/>
        </p:nvSpPr>
        <p:spPr>
          <a:xfrm>
            <a:off x="7162920" y="2438280"/>
            <a:ext cx="144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5"/>
          <p:cNvSpPr/>
          <p:nvPr/>
        </p:nvSpPr>
        <p:spPr>
          <a:xfrm>
            <a:off x="7421040" y="1996920"/>
            <a:ext cx="963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 isla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6"/>
          <p:cNvSpPr/>
          <p:nvPr/>
        </p:nvSpPr>
        <p:spPr>
          <a:xfrm>
            <a:off x="7421040" y="2301840"/>
            <a:ext cx="9648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crip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7"/>
          <p:cNvSpPr/>
          <p:nvPr/>
        </p:nvSpPr>
        <p:spPr>
          <a:xfrm>
            <a:off x="7526160" y="3444840"/>
            <a:ext cx="646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rain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8"/>
          <p:cNvSpPr/>
          <p:nvPr/>
        </p:nvSpPr>
        <p:spPr>
          <a:xfrm>
            <a:off x="7526160" y="3809880"/>
            <a:ext cx="646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rain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9"/>
          <p:cNvSpPr/>
          <p:nvPr/>
        </p:nvSpPr>
        <p:spPr>
          <a:xfrm>
            <a:off x="7525800" y="4191120"/>
            <a:ext cx="61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ver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0"/>
          <p:cNvSpPr/>
          <p:nvPr/>
        </p:nvSpPr>
        <p:spPr>
          <a:xfrm>
            <a:off x="7525800" y="4495680"/>
            <a:ext cx="61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ver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"/>
          <p:cNvSpPr/>
          <p:nvPr/>
        </p:nvSpPr>
        <p:spPr>
          <a:xfrm>
            <a:off x="7525080" y="4876920"/>
            <a:ext cx="70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estis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2"/>
          <p:cNvSpPr/>
          <p:nvPr/>
        </p:nvSpPr>
        <p:spPr>
          <a:xfrm>
            <a:off x="7525080" y="5181480"/>
            <a:ext cx="70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estis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7"/>
          <p:cNvSpPr/>
          <p:nvPr/>
        </p:nvSpPr>
        <p:spPr>
          <a:xfrm>
            <a:off x="7525800" y="2682720"/>
            <a:ext cx="666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rt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7"/>
          <p:cNvSpPr/>
          <p:nvPr/>
        </p:nvSpPr>
        <p:spPr>
          <a:xfrm>
            <a:off x="7525800" y="3063960"/>
            <a:ext cx="666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rt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53:08Z</dcterms:modified>
  <cp:revision>75</cp:revision>
  <dc:subject/>
  <dc:title>PowerPoint Presentation</dc:title>
</cp:coreProperties>
</file>